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07D6EC-DFDD-4EE7-ACA8-6578442E636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5963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1205" y="478971"/>
            <a:ext cx="6123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. Strain lis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2380438"/>
              </p:ext>
            </p:extLst>
          </p:nvPr>
        </p:nvGraphicFramePr>
        <p:xfrm>
          <a:off x="325856" y="985019"/>
          <a:ext cx="6398794" cy="6119055"/>
        </p:xfrm>
        <a:graphic>
          <a:graphicData uri="http://schemas.openxmlformats.org/drawingml/2006/table">
            <a:tbl>
              <a:tblPr/>
              <a:tblGrid>
                <a:gridCol w="9885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410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rain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tic  background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52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Ta/alpha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u2-</a:t>
                      </a:r>
                      <a:r>
                        <a:rPr lang="el-GR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98/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u2-</a:t>
                      </a:r>
                      <a:r>
                        <a:rPr lang="el-GR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98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ra3-52/ura3-52, lys2-801/lys2-801, HIS3/his3-</a:t>
                      </a:r>
                      <a:r>
                        <a:rPr lang="el-GR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200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P1/trp1-1, ade2-101/ade2-1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52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brary strains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 1327 different genomic loci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1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NT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2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NT2-</a:t>
                      </a:r>
                      <a:r>
                        <a:rPr lang="el-GR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TA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3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C1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4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C1-</a:t>
                      </a:r>
                      <a:r>
                        <a:rPr lang="el-GR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TA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5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S1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6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S1-</a:t>
                      </a:r>
                      <a:r>
                        <a:rPr lang="el-GR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TA::KanMx-MET3pr-GFP</a:t>
                      </a:r>
                      <a:r>
                        <a:rPr lang="en-US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7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ATG36::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8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LDS2::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09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NTS1::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0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ALPHA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1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SAM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2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TDH3::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3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4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GALS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RSM23::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en-US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LSpr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5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NT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6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NT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7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NT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/+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8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NT2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+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LDS2::MET13-LEU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19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M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0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WC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1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WC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/+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2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WC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+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LDS2::MET13-LEU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3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WC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4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M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5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M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/+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6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M23::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-MET3pr-GFP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ET13::ADE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+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LDS2::MET13-LEU2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7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DS2::CEG1-MET3pr-GFP-MET13-LEU2</a:t>
                      </a:r>
                      <a:r>
                        <a:rPr lang="en-US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8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DS2::CEG1-MET3pr-GFP-MET13-LEU2</a:t>
                      </a:r>
                      <a:r>
                        <a:rPr lang="en-US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3pr-mCherry</a:t>
                      </a:r>
                      <a:r>
                        <a:rPr lang="en-US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29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13::MET13-ADE2</a:t>
                      </a:r>
                      <a:r>
                        <a:rPr lang="en-US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30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nl-NL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13::MET13-ADE2</a:t>
                      </a:r>
                      <a:r>
                        <a:rPr lang="nl-NL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+</a:t>
                      </a:r>
                      <a:r>
                        <a:rPr lang="nl-NL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LDS2::MET13-LEU2</a:t>
                      </a:r>
                      <a:r>
                        <a:rPr lang="nl-NL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31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nl-NL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13::MET13-ADE2</a:t>
                      </a:r>
                      <a:r>
                        <a:rPr lang="nl-NL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nl-NL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DC20::URA3-MET13pr-mCherry</a:t>
                      </a:r>
                      <a:r>
                        <a:rPr lang="nl-NL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00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MY32</a:t>
                      </a: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800, </a:t>
                      </a:r>
                      <a:r>
                        <a:rPr lang="nl-NL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13::MET13-ADE2</a:t>
                      </a:r>
                      <a:r>
                        <a:rPr lang="nl-NL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+</a:t>
                      </a:r>
                      <a:r>
                        <a:rPr lang="nl-NL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LDS2::MET13-LEU2</a:t>
                      </a:r>
                      <a:r>
                        <a:rPr lang="nl-NL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r>
                        <a:rPr lang="nl-NL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</a:t>
                      </a:r>
                      <a:r>
                        <a:rPr lang="nl-NL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nl-NL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C20::URA3-MET13pr-mCherry</a:t>
                      </a:r>
                      <a:r>
                        <a:rPr lang="nl-NL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/-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13" marR="5013" marT="50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135554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421</Words>
  <Application>Microsoft Office PowerPoint</Application>
  <PresentationFormat>Letter Paper (8.5x11 in)</PresentationFormat>
  <Paragraphs>7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2</cp:revision>
  <cp:lastPrinted>2016-12-22T22:05:19Z</cp:lastPrinted>
  <dcterms:created xsi:type="dcterms:W3CDTF">2016-06-14T18:48:14Z</dcterms:created>
  <dcterms:modified xsi:type="dcterms:W3CDTF">2017-03-30T15:26:13Z</dcterms:modified>
</cp:coreProperties>
</file>